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4" y="-5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360极速浏览器下载\expression-of-ahnak-in-l.jpe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82"/>
          <a:stretch/>
        </p:blipFill>
        <p:spPr bwMode="auto">
          <a:xfrm>
            <a:off x="2172000" y="2099960"/>
            <a:ext cx="4800000" cy="31290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085567" y="2185055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p=1.36E-0</a:t>
            </a:r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3121571" y="2420888"/>
            <a:ext cx="792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3103569" y="2142391"/>
            <a:ext cx="18284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583174" y="1884516"/>
            <a:ext cx="9888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smtClean="0">
                <a:latin typeface="Times New Roman" pitchFamily="18" charset="0"/>
                <a:cs typeface="Times New Roman" pitchFamily="18" charset="0"/>
              </a:rPr>
              <a:t>p=3.38E-04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3121571" y="1884516"/>
            <a:ext cx="281858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293623" y="1621472"/>
            <a:ext cx="9888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3.63E-04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3103569" y="1610513"/>
            <a:ext cx="35566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525900" y="1348580"/>
            <a:ext cx="9888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0.274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83668" y="134858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48890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360极速浏览器下载\promoter-methylation-lev.jpe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27"/>
          <a:stretch/>
        </p:blipFill>
        <p:spPr bwMode="auto">
          <a:xfrm>
            <a:off x="814400" y="764704"/>
            <a:ext cx="4778896" cy="3368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直接连接符 4"/>
          <p:cNvCxnSpPr/>
          <p:nvPr/>
        </p:nvCxnSpPr>
        <p:spPr>
          <a:xfrm>
            <a:off x="1835696" y="1484784"/>
            <a:ext cx="864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835696" y="1290643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1.78E-06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1823517" y="1320359"/>
            <a:ext cx="1668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190403" y="1121450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1.05E-03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1835696" y="1170330"/>
            <a:ext cx="25922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754660" y="956345"/>
            <a:ext cx="117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0.106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1823517" y="980728"/>
            <a:ext cx="32525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254524" y="764704"/>
            <a:ext cx="117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Times New Roman" pitchFamily="18" charset="0"/>
                <a:cs typeface="Times New Roman" pitchFamily="18" charset="0"/>
              </a:rPr>
              <a:t>p=3.88E-03</a:t>
            </a:r>
            <a:endParaRPr lang="zh-CN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3" name="表格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5208743"/>
              </p:ext>
            </p:extLst>
          </p:nvPr>
        </p:nvGraphicFramePr>
        <p:xfrm>
          <a:off x="5796136" y="1124882"/>
          <a:ext cx="2857500" cy="2072640"/>
        </p:xfrm>
        <a:graphic>
          <a:graphicData uri="http://schemas.openxmlformats.org/drawingml/2006/table">
            <a:tbl>
              <a:tblPr/>
              <a:tblGrid>
                <a:gridCol w="1428750"/>
                <a:gridCol w="1428750"/>
              </a:tblGrid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dirty="0" err="1">
                          <a:effectLst/>
                          <a:latin typeface="inherit"/>
                        </a:rPr>
                        <a:t>Illumina</a:t>
                      </a:r>
                      <a:r>
                        <a:rPr lang="en-US" sz="1100" b="1" dirty="0">
                          <a:effectLst/>
                          <a:latin typeface="inherit"/>
                        </a:rPr>
                        <a:t> Id</a:t>
                      </a:r>
                      <a:endParaRPr lang="en-US" sz="1100" dirty="0">
                        <a:effectLst/>
                        <a:latin typeface="inheri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1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dirty="0" err="1">
                          <a:effectLst/>
                          <a:latin typeface="inherit"/>
                        </a:rPr>
                        <a:t>RefGene_group</a:t>
                      </a:r>
                      <a:endParaRPr lang="en-US" sz="1100" dirty="0">
                        <a:effectLst/>
                        <a:latin typeface="inherit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1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6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2344756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E0B5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E0B5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dirty="0">
                          <a:effectLst/>
                          <a:latin typeface="inherit"/>
                        </a:rPr>
                        <a:t>TSS15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E0B5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20B6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1834105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1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1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TSS2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1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0B7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0874086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dirty="0">
                          <a:effectLst/>
                          <a:latin typeface="inherit"/>
                        </a:rPr>
                        <a:t>TSS2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0B6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22134923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E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E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TSS15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E0B8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20B6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2103868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TSS15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DF18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0B7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20518446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A0B3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0B3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TSS15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A0B3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0B6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>
                          <a:effectLst/>
                          <a:latin typeface="inherit"/>
                        </a:rPr>
                        <a:t>cg1976455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0BC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dirty="0">
                          <a:effectLst/>
                          <a:latin typeface="inherit"/>
                        </a:rPr>
                        <a:t>TSS150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30B1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20B6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0BC2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9EB"/>
                    </a:solidFill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95536" y="731337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59532" y="5420370"/>
            <a:ext cx="81369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upplementary Figure 1.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Expression of AHNAK in TCGA data. A: Expression of AHNAK mRNA in liver hepatocellular carcinoma based on individual cancer stages. B: Promoter methylation level of AHNAK in Liver hepatocellular carcinoma. 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6814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66</Words>
  <Application>Microsoft Office PowerPoint</Application>
  <PresentationFormat>全屏显示(4:3)</PresentationFormat>
  <Paragraphs>2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yn</dc:creator>
  <cp:lastModifiedBy>Illumina</cp:lastModifiedBy>
  <cp:revision>14</cp:revision>
  <dcterms:created xsi:type="dcterms:W3CDTF">2021-02-07T13:37:48Z</dcterms:created>
  <dcterms:modified xsi:type="dcterms:W3CDTF">2021-08-10T08:05:19Z</dcterms:modified>
</cp:coreProperties>
</file>